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68" r:id="rId2"/>
    <p:sldId id="276" r:id="rId3"/>
    <p:sldId id="269" r:id="rId4"/>
    <p:sldId id="279" r:id="rId5"/>
    <p:sldId id="280" r:id="rId6"/>
    <p:sldId id="275" r:id="rId7"/>
    <p:sldId id="274" r:id="rId8"/>
    <p:sldId id="277" r:id="rId9"/>
    <p:sldId id="278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20" autoAdjust="0"/>
  </p:normalViewPr>
  <p:slideViewPr>
    <p:cSldViewPr snapToGrid="0" showGuides="1">
      <p:cViewPr varScale="1">
        <p:scale>
          <a:sx n="119" d="100"/>
          <a:sy n="119" d="100"/>
        </p:scale>
        <p:origin x="1296" y="102"/>
      </p:cViewPr>
      <p:guideLst>
        <p:guide orient="horz" pos="2160"/>
        <p:guide pos="286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5CC114-40BB-4F87-B7E2-E951C7EAF597}" type="datetimeFigureOut">
              <a:rPr lang="en-US" smtClean="0"/>
              <a:t>9/2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D3C674-5DC8-442A-8733-78D9C1E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476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D3C674-5DC8-442A-8733-78D9C1E9049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821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4609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4402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95621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8341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07848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963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4772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2966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6890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9807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1387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90565-6C53-4AFD-A999-4770D456B204}" type="datetimeFigureOut">
              <a:rPr lang="en-IN" smtClean="0"/>
              <a:t>24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F362C-7B02-4D6C-931F-48281A95F2B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02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>
            <a:extLst>
              <a:ext uri="{FF2B5EF4-FFF2-40B4-BE49-F238E27FC236}">
                <a16:creationId xmlns:a16="http://schemas.microsoft.com/office/drawing/2014/main" id="{052B43C0-9F2D-4C82-A487-912CD2455918}"/>
              </a:ext>
            </a:extLst>
          </p:cNvPr>
          <p:cNvSpPr txBox="1"/>
          <p:nvPr/>
        </p:nvSpPr>
        <p:spPr>
          <a:xfrm>
            <a:off x="368285" y="5994592"/>
            <a:ext cx="7872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1.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to assess  surface markers from Whole blood of SLE patients and healthy controls.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6189A7F4-20F1-4098-BD3F-3D7EF9728A93}"/>
              </a:ext>
            </a:extLst>
          </p:cNvPr>
          <p:cNvCxnSpPr>
            <a:cxnSpLocks/>
          </p:cNvCxnSpPr>
          <p:nvPr/>
        </p:nvCxnSpPr>
        <p:spPr>
          <a:xfrm>
            <a:off x="6430259" y="3171257"/>
            <a:ext cx="679626" cy="5335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" name="Group 17">
            <a:extLst>
              <a:ext uri="{FF2B5EF4-FFF2-40B4-BE49-F238E27FC236}">
                <a16:creationId xmlns:a16="http://schemas.microsoft.com/office/drawing/2014/main" id="{F98333DC-F9C9-41DC-AA24-1266836193A2}"/>
              </a:ext>
            </a:extLst>
          </p:cNvPr>
          <p:cNvGrpSpPr/>
          <p:nvPr/>
        </p:nvGrpSpPr>
        <p:grpSpPr>
          <a:xfrm>
            <a:off x="201491" y="1140019"/>
            <a:ext cx="8027966" cy="3653605"/>
            <a:chOff x="0" y="1060061"/>
            <a:chExt cx="8027966" cy="3653605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FEACA693-688C-7517-2229-8C19A49197FE}"/>
                </a:ext>
              </a:extLst>
            </p:cNvPr>
            <p:cNvGrpSpPr/>
            <p:nvPr/>
          </p:nvGrpSpPr>
          <p:grpSpPr>
            <a:xfrm>
              <a:off x="0" y="2008212"/>
              <a:ext cx="6853965" cy="1894864"/>
              <a:chOff x="0" y="2008212"/>
              <a:chExt cx="6853965" cy="1894864"/>
            </a:xfrm>
          </p:grpSpPr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DE75EBDB-18BA-4F00-A544-F587429C4F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16721" y="3003566"/>
                <a:ext cx="25504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EE148831-95BC-422D-9CD3-03E685857A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767" b="5035"/>
              <a:stretch/>
            </p:blipFill>
            <p:spPr>
              <a:xfrm>
                <a:off x="1802506" y="2461382"/>
                <a:ext cx="1219778" cy="1223100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C433C6A-3E3A-459A-A474-7355F0A17DC0}"/>
                  </a:ext>
                </a:extLst>
              </p:cNvPr>
              <p:cNvSpPr txBox="1"/>
              <p:nvPr/>
            </p:nvSpPr>
            <p:spPr>
              <a:xfrm>
                <a:off x="2170956" y="3624803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40F8578-33E1-410A-8B0B-1351ED8E6186}"/>
                  </a:ext>
                </a:extLst>
              </p:cNvPr>
              <p:cNvSpPr txBox="1"/>
              <p:nvPr/>
            </p:nvSpPr>
            <p:spPr>
              <a:xfrm rot="16200000">
                <a:off x="1484851" y="2861851"/>
                <a:ext cx="568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H</a:t>
                </a:r>
              </a:p>
            </p:txBody>
          </p:sp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CD095F8D-0D3C-43D8-9DDE-FFD9CF566E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807" b="3761"/>
              <a:stretch/>
            </p:blipFill>
            <p:spPr>
              <a:xfrm>
                <a:off x="3458289" y="2473431"/>
                <a:ext cx="1177361" cy="1223100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6FEBA25-DA74-4069-BB37-92420F0F5D8A}"/>
                  </a:ext>
                </a:extLst>
              </p:cNvPr>
              <p:cNvSpPr txBox="1"/>
              <p:nvPr/>
            </p:nvSpPr>
            <p:spPr>
              <a:xfrm rot="16200000">
                <a:off x="2956399" y="2861851"/>
                <a:ext cx="82078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VE/DEAD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C3B3B98-8447-4EFA-A046-BC9C9641AEBE}"/>
                  </a:ext>
                </a:extLst>
              </p:cNvPr>
              <p:cNvSpPr txBox="1"/>
              <p:nvPr/>
            </p:nvSpPr>
            <p:spPr>
              <a:xfrm>
                <a:off x="3787939" y="3592656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67FF9ABA-F2EE-482D-9246-FF3976ECC9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2284" y="3003566"/>
                <a:ext cx="21545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08C3D2A9-31C7-422C-8CB4-7C1A326241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0038" b="6119"/>
              <a:stretch/>
            </p:blipFill>
            <p:spPr>
              <a:xfrm>
                <a:off x="194790" y="2473431"/>
                <a:ext cx="1221931" cy="1255247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EA26291-E812-4862-B749-9D5DE59AFB0B}"/>
                  </a:ext>
                </a:extLst>
              </p:cNvPr>
              <p:cNvSpPr txBox="1"/>
              <p:nvPr/>
            </p:nvSpPr>
            <p:spPr>
              <a:xfrm>
                <a:off x="561063" y="3672244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60182A9-C0C2-4F91-BE81-104F184CD046}"/>
                  </a:ext>
                </a:extLst>
              </p:cNvPr>
              <p:cNvSpPr txBox="1"/>
              <p:nvPr/>
            </p:nvSpPr>
            <p:spPr>
              <a:xfrm rot="16200000">
                <a:off x="-195111" y="2861852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A882589C-8CCB-4785-9D88-BA40B61FD924}"/>
                  </a:ext>
                </a:extLst>
              </p:cNvPr>
              <p:cNvSpPr txBox="1"/>
              <p:nvPr/>
            </p:nvSpPr>
            <p:spPr>
              <a:xfrm rot="16200000">
                <a:off x="4668137" y="2799598"/>
                <a:ext cx="4965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A3D61F0F-4915-49F5-BB9C-F33F10B811DF}"/>
                  </a:ext>
                </a:extLst>
              </p:cNvPr>
              <p:cNvSpPr txBox="1"/>
              <p:nvPr/>
            </p:nvSpPr>
            <p:spPr>
              <a:xfrm>
                <a:off x="5404921" y="3592656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8</a:t>
                </a:r>
              </a:p>
            </p:txBody>
          </p: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id="{744EFC57-7EAC-4AC9-8C85-38CF955A12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35650" y="3003566"/>
                <a:ext cx="21545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>
                <a:extLst>
                  <a:ext uri="{FF2B5EF4-FFF2-40B4-BE49-F238E27FC236}">
                    <a16:creationId xmlns:a16="http://schemas.microsoft.com/office/drawing/2014/main" id="{E1CE4A63-C813-4CEE-BCBA-D1759895CC4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269447" y="2008212"/>
                <a:ext cx="584518" cy="93043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1DD2D7F-9761-A332-F315-39752924D6C8}"/>
                </a:ext>
              </a:extLst>
            </p:cNvPr>
            <p:cNvGrpSpPr/>
            <p:nvPr/>
          </p:nvGrpSpPr>
          <p:grpSpPr>
            <a:xfrm>
              <a:off x="6696806" y="1060061"/>
              <a:ext cx="1331160" cy="3653605"/>
              <a:chOff x="6696806" y="1060061"/>
              <a:chExt cx="1331160" cy="3653605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8CE3D8BF-D4A7-DBC1-5B3B-D72E642CA0F3}"/>
                  </a:ext>
                </a:extLst>
              </p:cNvPr>
              <p:cNvGrpSpPr/>
              <p:nvPr/>
            </p:nvGrpSpPr>
            <p:grpSpPr>
              <a:xfrm>
                <a:off x="6696806" y="1060061"/>
                <a:ext cx="1253242" cy="1238722"/>
                <a:chOff x="7406059" y="759196"/>
                <a:chExt cx="1253242" cy="1238722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1EA32E6F-ADCA-4458-A3BD-65D937850FEA}"/>
                    </a:ext>
                  </a:extLst>
                </p:cNvPr>
                <p:cNvSpPr txBox="1"/>
                <p:nvPr/>
              </p:nvSpPr>
              <p:spPr>
                <a:xfrm>
                  <a:off x="8034825" y="1767086"/>
                  <a:ext cx="6244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XCR5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F064EFDF-C05E-4A7E-956E-A908BE63216B}"/>
                    </a:ext>
                  </a:extLst>
                </p:cNvPr>
                <p:cNvSpPr txBox="1"/>
                <p:nvPr/>
              </p:nvSpPr>
              <p:spPr>
                <a:xfrm rot="16200000">
                  <a:off x="7210948" y="954307"/>
                  <a:ext cx="62105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8</a:t>
                  </a:r>
                </a:p>
              </p:txBody>
            </p:sp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F3F56199-6840-30A6-CF75-11492A385C9B}"/>
                  </a:ext>
                </a:extLst>
              </p:cNvPr>
              <p:cNvGrpSpPr/>
              <p:nvPr/>
            </p:nvGrpSpPr>
            <p:grpSpPr>
              <a:xfrm>
                <a:off x="6783663" y="3478684"/>
                <a:ext cx="1244303" cy="1234982"/>
                <a:chOff x="7617897" y="3995068"/>
                <a:chExt cx="1244303" cy="1234982"/>
              </a:xfrm>
            </p:grpSpPr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765AB184-53E6-4DDC-BDCE-9CD7CFF799C5}"/>
                    </a:ext>
                  </a:extLst>
                </p:cNvPr>
                <p:cNvSpPr txBox="1"/>
                <p:nvPr/>
              </p:nvSpPr>
              <p:spPr>
                <a:xfrm rot="16200000">
                  <a:off x="7422786" y="4190179"/>
                  <a:ext cx="62105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8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7FA5B3EA-DF1F-4905-97D1-100F338E8A05}"/>
                    </a:ext>
                  </a:extLst>
                </p:cNvPr>
                <p:cNvSpPr txBox="1"/>
                <p:nvPr/>
              </p:nvSpPr>
              <p:spPr>
                <a:xfrm>
                  <a:off x="8241147" y="4999218"/>
                  <a:ext cx="62105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COS</a:t>
                  </a:r>
                </a:p>
              </p:txBody>
            </p:sp>
          </p:grpSp>
        </p:grpSp>
      </p:grpSp>
      <p:sp>
        <p:nvSpPr>
          <p:cNvPr id="22" name="TextBox 21"/>
          <p:cNvSpPr txBox="1"/>
          <p:nvPr/>
        </p:nvSpPr>
        <p:spPr>
          <a:xfrm>
            <a:off x="368285" y="404261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8CB6323-24C0-CBE3-C4B6-DAB49CC0EB1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323" b="29555"/>
          <a:stretch/>
        </p:blipFill>
        <p:spPr>
          <a:xfrm>
            <a:off x="5128198" y="2507944"/>
            <a:ext cx="1249014" cy="12240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AB91E07-5EF2-4FBE-D0D6-224CACB7170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293" b="6511"/>
          <a:stretch/>
        </p:blipFill>
        <p:spPr>
          <a:xfrm>
            <a:off x="7123158" y="3164939"/>
            <a:ext cx="1338643" cy="131466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021EF45-7114-D4F4-1F2B-BAB7DBDC97C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819" b="6253"/>
          <a:stretch/>
        </p:blipFill>
        <p:spPr>
          <a:xfrm>
            <a:off x="7055456" y="742815"/>
            <a:ext cx="1327473" cy="1314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24965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52562" y="4277639"/>
            <a:ext cx="8304747" cy="1988430"/>
            <a:chOff x="86389" y="394636"/>
            <a:chExt cx="8304747" cy="198843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8238" t="-1" b="4829"/>
            <a:stretch/>
          </p:blipFill>
          <p:spPr>
            <a:xfrm>
              <a:off x="317220" y="477058"/>
              <a:ext cx="1578543" cy="1611624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/>
            <a:srcRect l="6736" b="8020"/>
            <a:stretch/>
          </p:blipFill>
          <p:spPr>
            <a:xfrm>
              <a:off x="2315628" y="477058"/>
              <a:ext cx="1693979" cy="1609344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/>
            <a:srcRect l="7685" t="-3850" r="-948" b="3850"/>
            <a:stretch/>
          </p:blipFill>
          <p:spPr>
            <a:xfrm>
              <a:off x="4600567" y="394636"/>
              <a:ext cx="1622833" cy="171287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6"/>
            <a:srcRect l="7534" b="7560"/>
            <a:stretch/>
          </p:blipFill>
          <p:spPr>
            <a:xfrm>
              <a:off x="6755786" y="498162"/>
              <a:ext cx="1635350" cy="1609344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60182A9-C0C2-4F91-BE81-104F184CD046}"/>
                </a:ext>
              </a:extLst>
            </p:cNvPr>
            <p:cNvSpPr txBox="1"/>
            <p:nvPr/>
          </p:nvSpPr>
          <p:spPr>
            <a:xfrm rot="16200000">
              <a:off x="-108722" y="1187417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EA26291-E812-4862-B749-9D5DE59AFB0B}"/>
                </a:ext>
              </a:extLst>
            </p:cNvPr>
            <p:cNvSpPr txBox="1"/>
            <p:nvPr/>
          </p:nvSpPr>
          <p:spPr>
            <a:xfrm>
              <a:off x="897947" y="2107506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40F8578-33E1-410A-8B0B-1351ED8E6186}"/>
                </a:ext>
              </a:extLst>
            </p:cNvPr>
            <p:cNvSpPr txBox="1"/>
            <p:nvPr/>
          </p:nvSpPr>
          <p:spPr>
            <a:xfrm rot="16200000">
              <a:off x="1986874" y="1187416"/>
              <a:ext cx="568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C433C6A-3E3A-459A-A474-7355F0A17DC0}"/>
                </a:ext>
              </a:extLst>
            </p:cNvPr>
            <p:cNvSpPr txBox="1"/>
            <p:nvPr/>
          </p:nvSpPr>
          <p:spPr>
            <a:xfrm>
              <a:off x="3094982" y="2152234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6FEBA25-DA74-4069-BB37-92420F0F5D8A}"/>
                </a:ext>
              </a:extLst>
            </p:cNvPr>
            <p:cNvSpPr txBox="1"/>
            <p:nvPr/>
          </p:nvSpPr>
          <p:spPr>
            <a:xfrm rot="16200000">
              <a:off x="4074759" y="1187416"/>
              <a:ext cx="820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/DEAD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C433C6A-3E3A-459A-A474-7355F0A17DC0}"/>
                </a:ext>
              </a:extLst>
            </p:cNvPr>
            <p:cNvSpPr txBox="1"/>
            <p:nvPr/>
          </p:nvSpPr>
          <p:spPr>
            <a:xfrm>
              <a:off x="5334749" y="2119753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6FEBA25-DA74-4069-BB37-92420F0F5D8A}"/>
                </a:ext>
              </a:extLst>
            </p:cNvPr>
            <p:cNvSpPr txBox="1"/>
            <p:nvPr/>
          </p:nvSpPr>
          <p:spPr>
            <a:xfrm rot="16200000">
              <a:off x="6254831" y="1166314"/>
              <a:ext cx="820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5R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C433C6A-3E3A-459A-A474-7355F0A17DC0}"/>
                </a:ext>
              </a:extLst>
            </p:cNvPr>
            <p:cNvSpPr txBox="1"/>
            <p:nvPr/>
          </p:nvSpPr>
          <p:spPr>
            <a:xfrm>
              <a:off x="7452335" y="2086402"/>
              <a:ext cx="8090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5RO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DE75EBDB-18BA-4F00-A544-F587429C4F89}"/>
                </a:ext>
              </a:extLst>
            </p:cNvPr>
            <p:cNvCxnSpPr>
              <a:cxnSpLocks/>
            </p:cNvCxnSpPr>
            <p:nvPr/>
          </p:nvCxnSpPr>
          <p:spPr>
            <a:xfrm>
              <a:off x="1900639" y="1378193"/>
              <a:ext cx="25504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DE75EBDB-18BA-4F00-A544-F587429C4F89}"/>
                </a:ext>
              </a:extLst>
            </p:cNvPr>
            <p:cNvCxnSpPr>
              <a:cxnSpLocks/>
            </p:cNvCxnSpPr>
            <p:nvPr/>
          </p:nvCxnSpPr>
          <p:spPr>
            <a:xfrm>
              <a:off x="4009607" y="1370348"/>
              <a:ext cx="25504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DE75EBDB-18BA-4F00-A544-F587429C4F89}"/>
                </a:ext>
              </a:extLst>
            </p:cNvPr>
            <p:cNvCxnSpPr>
              <a:cxnSpLocks/>
            </p:cNvCxnSpPr>
            <p:nvPr/>
          </p:nvCxnSpPr>
          <p:spPr>
            <a:xfrm>
              <a:off x="6191650" y="1295126"/>
              <a:ext cx="25504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Group 46"/>
          <p:cNvGrpSpPr/>
          <p:nvPr/>
        </p:nvGrpSpPr>
        <p:grpSpPr>
          <a:xfrm>
            <a:off x="299416" y="257103"/>
            <a:ext cx="7682182" cy="1840176"/>
            <a:chOff x="201805" y="2769800"/>
            <a:chExt cx="7682182" cy="1840176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7"/>
            <a:srcRect l="11708" b="6001"/>
            <a:stretch/>
          </p:blipFill>
          <p:spPr>
            <a:xfrm>
              <a:off x="529209" y="2769800"/>
              <a:ext cx="1569140" cy="1609344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8"/>
            <a:srcRect l="7622" t="1" b="4844"/>
            <a:stretch/>
          </p:blipFill>
          <p:spPr>
            <a:xfrm>
              <a:off x="3496383" y="2769800"/>
              <a:ext cx="1621885" cy="1609344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60182A9-C0C2-4F91-BE81-104F184CD046}"/>
                </a:ext>
              </a:extLst>
            </p:cNvPr>
            <p:cNvSpPr txBox="1"/>
            <p:nvPr/>
          </p:nvSpPr>
          <p:spPr>
            <a:xfrm rot="16200000">
              <a:off x="6694" y="3361125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EA26291-E812-4862-B749-9D5DE59AFB0B}"/>
                </a:ext>
              </a:extLst>
            </p:cNvPr>
            <p:cNvSpPr txBox="1"/>
            <p:nvPr/>
          </p:nvSpPr>
          <p:spPr>
            <a:xfrm>
              <a:off x="1003251" y="4379144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40F8578-33E1-410A-8B0B-1351ED8E6186}"/>
                </a:ext>
              </a:extLst>
            </p:cNvPr>
            <p:cNvSpPr txBox="1"/>
            <p:nvPr/>
          </p:nvSpPr>
          <p:spPr>
            <a:xfrm rot="16200000">
              <a:off x="3112713" y="3324225"/>
              <a:ext cx="568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C433C6A-3E3A-459A-A474-7355F0A17DC0}"/>
                </a:ext>
              </a:extLst>
            </p:cNvPr>
            <p:cNvSpPr txBox="1"/>
            <p:nvPr/>
          </p:nvSpPr>
          <p:spPr>
            <a:xfrm>
              <a:off x="4174624" y="4329560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40F8578-33E1-410A-8B0B-1351ED8E6186}"/>
                </a:ext>
              </a:extLst>
            </p:cNvPr>
            <p:cNvSpPr txBox="1"/>
            <p:nvPr/>
          </p:nvSpPr>
          <p:spPr>
            <a:xfrm rot="16200000">
              <a:off x="6167198" y="3387424"/>
              <a:ext cx="568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s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C433C6A-3E3A-459A-A474-7355F0A17DC0}"/>
                </a:ext>
              </a:extLst>
            </p:cNvPr>
            <p:cNvSpPr txBox="1"/>
            <p:nvPr/>
          </p:nvSpPr>
          <p:spPr>
            <a:xfrm>
              <a:off x="7262934" y="4367536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</a:p>
          </p:txBody>
        </p: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DE75EBDB-18BA-4F00-A544-F587429C4F89}"/>
                </a:ext>
              </a:extLst>
            </p:cNvPr>
            <p:cNvCxnSpPr>
              <a:cxnSpLocks/>
            </p:cNvCxnSpPr>
            <p:nvPr/>
          </p:nvCxnSpPr>
          <p:spPr>
            <a:xfrm>
              <a:off x="2098349" y="3474896"/>
              <a:ext cx="923984" cy="94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DE75EBDB-18BA-4F00-A544-F587429C4F89}"/>
                </a:ext>
              </a:extLst>
            </p:cNvPr>
            <p:cNvCxnSpPr>
              <a:cxnSpLocks/>
            </p:cNvCxnSpPr>
            <p:nvPr/>
          </p:nvCxnSpPr>
          <p:spPr>
            <a:xfrm>
              <a:off x="5107624" y="3493391"/>
              <a:ext cx="923984" cy="94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/>
          <p:cNvGrpSpPr/>
          <p:nvPr/>
        </p:nvGrpSpPr>
        <p:grpSpPr>
          <a:xfrm>
            <a:off x="414831" y="2241153"/>
            <a:ext cx="7759201" cy="1855462"/>
            <a:chOff x="305458" y="4972472"/>
            <a:chExt cx="7759201" cy="1855462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9"/>
            <a:srcRect l="9432" b="5381"/>
            <a:stretch/>
          </p:blipFill>
          <p:spPr>
            <a:xfrm>
              <a:off x="3496383" y="4972472"/>
              <a:ext cx="1599133" cy="1609344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60182A9-C0C2-4F91-BE81-104F184CD046}"/>
                </a:ext>
              </a:extLst>
            </p:cNvPr>
            <p:cNvSpPr txBox="1"/>
            <p:nvPr/>
          </p:nvSpPr>
          <p:spPr>
            <a:xfrm rot="16200000">
              <a:off x="110347" y="5749518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EA26291-E812-4862-B749-9D5DE59AFB0B}"/>
                </a:ext>
              </a:extLst>
            </p:cNvPr>
            <p:cNvSpPr txBox="1"/>
            <p:nvPr/>
          </p:nvSpPr>
          <p:spPr>
            <a:xfrm>
              <a:off x="1065624" y="6589459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EA26291-E812-4862-B749-9D5DE59AFB0B}"/>
                </a:ext>
              </a:extLst>
            </p:cNvPr>
            <p:cNvSpPr txBox="1"/>
            <p:nvPr/>
          </p:nvSpPr>
          <p:spPr>
            <a:xfrm>
              <a:off x="4059208" y="6597102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40F8578-33E1-410A-8B0B-1351ED8E6186}"/>
                </a:ext>
              </a:extLst>
            </p:cNvPr>
            <p:cNvSpPr txBox="1"/>
            <p:nvPr/>
          </p:nvSpPr>
          <p:spPr>
            <a:xfrm rot="16200000">
              <a:off x="3121280" y="5550556"/>
              <a:ext cx="568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40F8578-33E1-410A-8B0B-1351ED8E6186}"/>
                </a:ext>
              </a:extLst>
            </p:cNvPr>
            <p:cNvSpPr txBox="1"/>
            <p:nvPr/>
          </p:nvSpPr>
          <p:spPr>
            <a:xfrm rot="16200000">
              <a:off x="6150362" y="5550556"/>
              <a:ext cx="568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C433C6A-3E3A-459A-A474-7355F0A17DC0}"/>
                </a:ext>
              </a:extLst>
            </p:cNvPr>
            <p:cNvSpPr txBox="1"/>
            <p:nvPr/>
          </p:nvSpPr>
          <p:spPr>
            <a:xfrm>
              <a:off x="7443606" y="6551947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</a:p>
          </p:txBody>
        </p: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DE75EBDB-18BA-4F00-A544-F587429C4F89}"/>
                </a:ext>
              </a:extLst>
            </p:cNvPr>
            <p:cNvCxnSpPr>
              <a:cxnSpLocks/>
            </p:cNvCxnSpPr>
            <p:nvPr/>
          </p:nvCxnSpPr>
          <p:spPr>
            <a:xfrm>
              <a:off x="2091267" y="5665972"/>
              <a:ext cx="923984" cy="94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DE75EBDB-18BA-4F00-A544-F587429C4F89}"/>
                </a:ext>
              </a:extLst>
            </p:cNvPr>
            <p:cNvCxnSpPr>
              <a:cxnSpLocks/>
            </p:cNvCxnSpPr>
            <p:nvPr/>
          </p:nvCxnSpPr>
          <p:spPr>
            <a:xfrm>
              <a:off x="5095516" y="5656523"/>
              <a:ext cx="923984" cy="944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86643" y="-10105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2 a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21445" y="200921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2b 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86643" y="4113674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2c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52B43C0-9F2D-4C82-A487-912CD2455918}"/>
              </a:ext>
            </a:extLst>
          </p:cNvPr>
          <p:cNvSpPr txBox="1"/>
          <p:nvPr/>
        </p:nvSpPr>
        <p:spPr>
          <a:xfrm>
            <a:off x="239349" y="6298540"/>
            <a:ext cx="8317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2a. Percentage of CD8+ T cells in PBMC of SLE patients.  2b. percentage of purity of CD8+ T cells after isolation.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 2c. Gating strategy to determine naïve, effector and memory compartments of CD8+ T cells.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10"/>
          <a:srcRect l="6959" b="5489"/>
          <a:stretch/>
        </p:blipFill>
        <p:spPr>
          <a:xfrm>
            <a:off x="6666959" y="169206"/>
            <a:ext cx="1629572" cy="1609344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11"/>
          <a:srcRect l="10633" b="5062"/>
          <a:stretch/>
        </p:blipFill>
        <p:spPr>
          <a:xfrm>
            <a:off x="639260" y="2240044"/>
            <a:ext cx="1538498" cy="1609344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12"/>
          <a:srcRect l="7494" b="3173"/>
          <a:stretch/>
        </p:blipFill>
        <p:spPr>
          <a:xfrm>
            <a:off x="6735062" y="2172685"/>
            <a:ext cx="1561469" cy="1609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633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F029815C-F901-4287-B8D6-8B061627ACE3}"/>
              </a:ext>
            </a:extLst>
          </p:cNvPr>
          <p:cNvSpPr txBox="1"/>
          <p:nvPr/>
        </p:nvSpPr>
        <p:spPr>
          <a:xfrm>
            <a:off x="116064" y="4921662"/>
            <a:ext cx="9380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. Fig 3.  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to determine transcription factor and cytokines staining from CD8+  cells of SLE Patients and healthy controls.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116065" y="762813"/>
            <a:ext cx="7691002" cy="3344410"/>
            <a:chOff x="116065" y="762813"/>
            <a:chExt cx="7691002" cy="3344410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E8AA617-F964-4C32-AE53-BC514CF8A35F}"/>
                </a:ext>
              </a:extLst>
            </p:cNvPr>
            <p:cNvSpPr txBox="1"/>
            <p:nvPr/>
          </p:nvSpPr>
          <p:spPr>
            <a:xfrm rot="16200000">
              <a:off x="-79046" y="2546606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096F725-548F-4E1B-85A8-DB570960EAA6}"/>
                </a:ext>
              </a:extLst>
            </p:cNvPr>
            <p:cNvSpPr txBox="1"/>
            <p:nvPr/>
          </p:nvSpPr>
          <p:spPr>
            <a:xfrm>
              <a:off x="661268" y="3276072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02987A70-23FA-4AD1-9D85-9EEC4595072D}"/>
                </a:ext>
              </a:extLst>
            </p:cNvPr>
            <p:cNvCxnSpPr>
              <a:cxnSpLocks/>
            </p:cNvCxnSpPr>
            <p:nvPr/>
          </p:nvCxnSpPr>
          <p:spPr>
            <a:xfrm>
              <a:off x="1467944" y="2731933"/>
              <a:ext cx="3528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775B00C-2316-4DD7-8AD7-9A89877C572D}"/>
                </a:ext>
              </a:extLst>
            </p:cNvPr>
            <p:cNvSpPr txBox="1"/>
            <p:nvPr/>
          </p:nvSpPr>
          <p:spPr>
            <a:xfrm rot="16200000">
              <a:off x="1652005" y="2567173"/>
              <a:ext cx="568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A6761CE-F912-4C99-9297-05F70BD66F9D}"/>
                </a:ext>
              </a:extLst>
            </p:cNvPr>
            <p:cNvSpPr txBox="1"/>
            <p:nvPr/>
          </p:nvSpPr>
          <p:spPr>
            <a:xfrm>
              <a:off x="2428684" y="3325125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FB5E3873-C827-4EB5-86FB-CC6CBABB1920}"/>
                </a:ext>
              </a:extLst>
            </p:cNvPr>
            <p:cNvCxnSpPr>
              <a:cxnSpLocks/>
            </p:cNvCxnSpPr>
            <p:nvPr/>
          </p:nvCxnSpPr>
          <p:spPr>
            <a:xfrm>
              <a:off x="3303828" y="2760260"/>
              <a:ext cx="3528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E655C9F-3897-4085-9AC3-F656ED833BE4}"/>
                </a:ext>
              </a:extLst>
            </p:cNvPr>
            <p:cNvSpPr txBox="1"/>
            <p:nvPr/>
          </p:nvSpPr>
          <p:spPr>
            <a:xfrm rot="16200000">
              <a:off x="3380679" y="2567173"/>
              <a:ext cx="820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/DEAD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C5A8810-A01B-4940-9B28-50F647892293}"/>
                </a:ext>
              </a:extLst>
            </p:cNvPr>
            <p:cNvSpPr txBox="1"/>
            <p:nvPr/>
          </p:nvSpPr>
          <p:spPr>
            <a:xfrm>
              <a:off x="4139663" y="3325124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6E254847-EF28-40D6-B863-F0BFC18C88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40054" y="1742542"/>
              <a:ext cx="1087836" cy="93073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8324" b="5514"/>
            <a:stretch/>
          </p:blipFill>
          <p:spPr>
            <a:xfrm>
              <a:off x="2148587" y="2128731"/>
              <a:ext cx="1234149" cy="1225296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/>
            <a:srcRect l="9649" t="-641" r="-2210" b="5831"/>
            <a:stretch/>
          </p:blipFill>
          <p:spPr>
            <a:xfrm>
              <a:off x="3906487" y="2151080"/>
              <a:ext cx="1215219" cy="1225296"/>
            </a:xfrm>
            <a:prstGeom prst="rect">
              <a:avLst/>
            </a:prstGeom>
          </p:spPr>
        </p:pic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6E254847-EF28-40D6-B863-F0BFC18C88A5}"/>
                </a:ext>
              </a:extLst>
            </p:cNvPr>
            <p:cNvCxnSpPr>
              <a:cxnSpLocks/>
            </p:cNvCxnSpPr>
            <p:nvPr/>
          </p:nvCxnSpPr>
          <p:spPr>
            <a:xfrm>
              <a:off x="5096914" y="2942014"/>
              <a:ext cx="1236315" cy="56489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4"/>
            <a:srcRect l="8192" t="552" b="7122"/>
            <a:stretch/>
          </p:blipFill>
          <p:spPr>
            <a:xfrm>
              <a:off x="6569301" y="762813"/>
              <a:ext cx="1237766" cy="1225296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E655C9F-3897-4085-9AC3-F656ED833BE4}"/>
                </a:ext>
              </a:extLst>
            </p:cNvPr>
            <p:cNvSpPr txBox="1"/>
            <p:nvPr/>
          </p:nvSpPr>
          <p:spPr>
            <a:xfrm rot="16200000">
              <a:off x="6043493" y="1141108"/>
              <a:ext cx="820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1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C5A8810-A01B-4940-9B28-50F647892293}"/>
                </a:ext>
              </a:extLst>
            </p:cNvPr>
            <p:cNvSpPr txBox="1"/>
            <p:nvPr/>
          </p:nvSpPr>
          <p:spPr>
            <a:xfrm>
              <a:off x="7077467" y="2001042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l-GR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γ</a:t>
              </a:r>
              <a:endPara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5"/>
            <a:srcRect l="8058" b="5051"/>
            <a:stretch/>
          </p:blipFill>
          <p:spPr>
            <a:xfrm>
              <a:off x="6569301" y="2651095"/>
              <a:ext cx="1205320" cy="1225296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E655C9F-3897-4085-9AC3-F656ED833BE4}"/>
                </a:ext>
              </a:extLst>
            </p:cNvPr>
            <p:cNvSpPr txBox="1"/>
            <p:nvPr/>
          </p:nvSpPr>
          <p:spPr>
            <a:xfrm rot="16200000">
              <a:off x="6043493" y="3034534"/>
              <a:ext cx="820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omes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C5A8810-A01B-4940-9B28-50F647892293}"/>
                </a:ext>
              </a:extLst>
            </p:cNvPr>
            <p:cNvSpPr txBox="1"/>
            <p:nvPr/>
          </p:nvSpPr>
          <p:spPr>
            <a:xfrm>
              <a:off x="6979610" y="3876391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F-</a:t>
              </a:r>
              <a:r>
                <a:rPr lang="el-GR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31480" y="23554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117CEF3-C9DB-450C-974F-EF4CFC7782C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246" b="5221"/>
          <a:stretch/>
        </p:blipFill>
        <p:spPr>
          <a:xfrm>
            <a:off x="277420" y="2152376"/>
            <a:ext cx="1190622" cy="122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06138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36E5E5C-9169-6E3E-2534-BA7715D99E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55" b="6134"/>
          <a:stretch/>
        </p:blipFill>
        <p:spPr>
          <a:xfrm>
            <a:off x="412718" y="2461976"/>
            <a:ext cx="1244197" cy="124358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420E683-1AE1-330D-56CE-65EF452518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05" b="6083"/>
          <a:stretch/>
        </p:blipFill>
        <p:spPr>
          <a:xfrm>
            <a:off x="2156663" y="2461976"/>
            <a:ext cx="1264545" cy="124358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51CEC5C-6814-D27D-BC38-5EA14E2BBF2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345" t="-2988" r="-1470" b="2988"/>
          <a:stretch/>
        </p:blipFill>
        <p:spPr>
          <a:xfrm>
            <a:off x="3920956" y="2378309"/>
            <a:ext cx="1255625" cy="132725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13BF602-D34D-1CE3-E48E-648D2A4DDDD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894" b="6295"/>
          <a:stretch/>
        </p:blipFill>
        <p:spPr>
          <a:xfrm>
            <a:off x="5676329" y="2378309"/>
            <a:ext cx="1228286" cy="124358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37D24C9-9208-ECB6-1D5D-A38BC18FB36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594" b="5251"/>
          <a:stretch/>
        </p:blipFill>
        <p:spPr>
          <a:xfrm>
            <a:off x="7336148" y="2378309"/>
            <a:ext cx="1245408" cy="12435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6A54D73-0772-407D-4AF7-80AEA2AA490F}"/>
              </a:ext>
            </a:extLst>
          </p:cNvPr>
          <p:cNvSpPr txBox="1"/>
          <p:nvPr/>
        </p:nvSpPr>
        <p:spPr>
          <a:xfrm rot="16200000">
            <a:off x="22505" y="2926518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BEF37E12-39A5-4E78-012D-E886391F8E76}"/>
              </a:ext>
            </a:extLst>
          </p:cNvPr>
          <p:cNvCxnSpPr>
            <a:cxnSpLocks/>
          </p:cNvCxnSpPr>
          <p:nvPr/>
        </p:nvCxnSpPr>
        <p:spPr>
          <a:xfrm>
            <a:off x="1656915" y="3006617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1F46888B-B5B9-4916-B505-4631BAA09044}"/>
              </a:ext>
            </a:extLst>
          </p:cNvPr>
          <p:cNvCxnSpPr>
            <a:cxnSpLocks/>
          </p:cNvCxnSpPr>
          <p:nvPr/>
        </p:nvCxnSpPr>
        <p:spPr>
          <a:xfrm>
            <a:off x="3421208" y="2989297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360902F7-7CCB-54F1-87FA-226B721633AA}"/>
              </a:ext>
            </a:extLst>
          </p:cNvPr>
          <p:cNvCxnSpPr>
            <a:cxnSpLocks/>
          </p:cNvCxnSpPr>
          <p:nvPr/>
        </p:nvCxnSpPr>
        <p:spPr>
          <a:xfrm>
            <a:off x="5176581" y="2971977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5174BC4-64B5-1155-461F-4FE78737B20D}"/>
              </a:ext>
            </a:extLst>
          </p:cNvPr>
          <p:cNvCxnSpPr>
            <a:cxnSpLocks/>
          </p:cNvCxnSpPr>
          <p:nvPr/>
        </p:nvCxnSpPr>
        <p:spPr>
          <a:xfrm>
            <a:off x="6904615" y="2894322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E432E024-3D03-C974-5813-755B4803D29C}"/>
              </a:ext>
            </a:extLst>
          </p:cNvPr>
          <p:cNvSpPr txBox="1"/>
          <p:nvPr/>
        </p:nvSpPr>
        <p:spPr>
          <a:xfrm>
            <a:off x="829210" y="3705560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02EB785-FA7F-2B97-45DD-0722567A817E}"/>
              </a:ext>
            </a:extLst>
          </p:cNvPr>
          <p:cNvSpPr txBox="1"/>
          <p:nvPr/>
        </p:nvSpPr>
        <p:spPr>
          <a:xfrm rot="16200000">
            <a:off x="1807724" y="2900219"/>
            <a:ext cx="5684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8E2206D-8BAA-5A0A-3D5A-9C8F55315BC3}"/>
              </a:ext>
            </a:extLst>
          </p:cNvPr>
          <p:cNvSpPr txBox="1"/>
          <p:nvPr/>
        </p:nvSpPr>
        <p:spPr>
          <a:xfrm>
            <a:off x="2655276" y="3705560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D9B726D-7217-B1B3-92FC-DF60D8053D1D}"/>
              </a:ext>
            </a:extLst>
          </p:cNvPr>
          <p:cNvSpPr txBox="1"/>
          <p:nvPr/>
        </p:nvSpPr>
        <p:spPr>
          <a:xfrm rot="16200000">
            <a:off x="3395148" y="2891201"/>
            <a:ext cx="8207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/DEA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A487E4-41EB-167A-2070-4EE0F4686B5C}"/>
              </a:ext>
            </a:extLst>
          </p:cNvPr>
          <p:cNvSpPr txBox="1"/>
          <p:nvPr/>
        </p:nvSpPr>
        <p:spPr>
          <a:xfrm>
            <a:off x="4315694" y="3705560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8783E9B-62E5-4560-A52B-6A2BDE19FFD1}"/>
              </a:ext>
            </a:extLst>
          </p:cNvPr>
          <p:cNvSpPr txBox="1"/>
          <p:nvPr/>
        </p:nvSpPr>
        <p:spPr>
          <a:xfrm rot="16200000">
            <a:off x="5169462" y="2673285"/>
            <a:ext cx="8207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en-I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989E9CD-3034-12EB-BA50-92C4DF142F9B}"/>
              </a:ext>
            </a:extLst>
          </p:cNvPr>
          <p:cNvSpPr txBox="1"/>
          <p:nvPr/>
        </p:nvSpPr>
        <p:spPr>
          <a:xfrm>
            <a:off x="6215946" y="3629748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0CC939F-D2C5-6B27-804A-3E2B5C4B414F}"/>
              </a:ext>
            </a:extLst>
          </p:cNvPr>
          <p:cNvSpPr txBox="1"/>
          <p:nvPr/>
        </p:nvSpPr>
        <p:spPr>
          <a:xfrm rot="16200000">
            <a:off x="6878555" y="2673285"/>
            <a:ext cx="8207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omes</a:t>
            </a:r>
            <a:endParaRPr lang="en-I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F72BB2F-8D42-6B6B-7A5B-9DDD4A77869E}"/>
              </a:ext>
            </a:extLst>
          </p:cNvPr>
          <p:cNvSpPr txBox="1"/>
          <p:nvPr/>
        </p:nvSpPr>
        <p:spPr>
          <a:xfrm>
            <a:off x="7805671" y="3590144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endParaRPr lang="en-I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330EA60-C2FC-423C-E572-37FFB4986AEE}"/>
              </a:ext>
            </a:extLst>
          </p:cNvPr>
          <p:cNvSpPr txBox="1"/>
          <p:nvPr/>
        </p:nvSpPr>
        <p:spPr>
          <a:xfrm>
            <a:off x="714695" y="5057237"/>
            <a:ext cx="7712029" cy="5693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. Fig 4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. </a:t>
            </a:r>
            <a: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Gating strategy to determine transcription factors from both SLE and healthy controls from PBMCS.</a:t>
            </a:r>
            <a:b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</a:br>
            <a:endParaRPr lang="en-IN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DEFAD2C-02DE-8A7E-2BB8-65132DFD8236}"/>
              </a:ext>
            </a:extLst>
          </p:cNvPr>
          <p:cNvSpPr txBox="1"/>
          <p:nvPr/>
        </p:nvSpPr>
        <p:spPr>
          <a:xfrm>
            <a:off x="231480" y="23554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4</a:t>
            </a:r>
          </a:p>
        </p:txBody>
      </p:sp>
    </p:spTree>
    <p:extLst>
      <p:ext uri="{BB962C8B-B14F-4D97-AF65-F5344CB8AC3E}">
        <p14:creationId xmlns:p14="http://schemas.microsoft.com/office/powerpoint/2010/main" val="5963413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EC4A474-72F3-0093-2A05-3BF2D703BB0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29" t="-4012" b="4012"/>
          <a:stretch/>
        </p:blipFill>
        <p:spPr>
          <a:xfrm>
            <a:off x="300282" y="2647182"/>
            <a:ext cx="1312805" cy="13536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4FC0CED-67A7-E31C-E562-64560768ECC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04" b="3733"/>
          <a:stretch/>
        </p:blipFill>
        <p:spPr>
          <a:xfrm>
            <a:off x="2019659" y="2702190"/>
            <a:ext cx="1285978" cy="124358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31B259B-7931-E5D0-F0DB-2ECFF8CEE25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706" b="6291"/>
          <a:stretch/>
        </p:blipFill>
        <p:spPr>
          <a:xfrm>
            <a:off x="3832636" y="2702190"/>
            <a:ext cx="1284687" cy="124358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B9D2025-DEBB-0E3C-DA24-8B31782DC9A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253" b="5010"/>
          <a:stretch/>
        </p:blipFill>
        <p:spPr>
          <a:xfrm>
            <a:off x="7170820" y="809164"/>
            <a:ext cx="1243012" cy="124358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393DFA9-3686-C453-1CB5-B4F50FE36B3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186" b="6826"/>
          <a:stretch/>
        </p:blipFill>
        <p:spPr>
          <a:xfrm>
            <a:off x="7170820" y="4185044"/>
            <a:ext cx="1256835" cy="1242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4936698-9A25-1725-207C-2B181B44273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842" b="3378"/>
          <a:stretch/>
        </p:blipFill>
        <p:spPr>
          <a:xfrm>
            <a:off x="5644322" y="2647182"/>
            <a:ext cx="1325789" cy="13536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12EFD0C-A1F5-14C3-C970-C66E0B61271C}"/>
              </a:ext>
            </a:extLst>
          </p:cNvPr>
          <p:cNvSpPr txBox="1"/>
          <p:nvPr/>
        </p:nvSpPr>
        <p:spPr>
          <a:xfrm>
            <a:off x="231480" y="23554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39FFA76-C7D1-8A74-CC8F-BA8475CEBB3F}"/>
              </a:ext>
            </a:extLst>
          </p:cNvPr>
          <p:cNvSpPr txBox="1"/>
          <p:nvPr/>
        </p:nvSpPr>
        <p:spPr>
          <a:xfrm>
            <a:off x="376990" y="5764142"/>
            <a:ext cx="8654716" cy="5693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. Fig 5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ating strategy to determine cytotoxic and inflammatory cytokines  from both SLE and healthy controls from PBMCS.</a:t>
            </a:r>
            <a:b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</a:br>
            <a:endParaRPr kumimoji="0" lang="en-IN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60BFB31-2629-D686-A940-F6A117937120}"/>
              </a:ext>
            </a:extLst>
          </p:cNvPr>
          <p:cNvSpPr txBox="1"/>
          <p:nvPr/>
        </p:nvSpPr>
        <p:spPr>
          <a:xfrm rot="16200000">
            <a:off x="-10244" y="3182732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4867865-DEC1-91A8-5731-6C69EC0B8ADD}"/>
              </a:ext>
            </a:extLst>
          </p:cNvPr>
          <p:cNvSpPr txBox="1"/>
          <p:nvPr/>
        </p:nvSpPr>
        <p:spPr>
          <a:xfrm>
            <a:off x="755698" y="3954212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B7678A6-964E-A958-6CC9-0169B1B40698}"/>
              </a:ext>
            </a:extLst>
          </p:cNvPr>
          <p:cNvCxnSpPr>
            <a:cxnSpLocks/>
          </p:cNvCxnSpPr>
          <p:nvPr/>
        </p:nvCxnSpPr>
        <p:spPr>
          <a:xfrm>
            <a:off x="1613087" y="3255269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88C5C23-E3F2-F99F-F94A-1BBC8083E9C1}"/>
              </a:ext>
            </a:extLst>
          </p:cNvPr>
          <p:cNvSpPr txBox="1"/>
          <p:nvPr/>
        </p:nvSpPr>
        <p:spPr>
          <a:xfrm rot="16200000">
            <a:off x="1732028" y="3139853"/>
            <a:ext cx="5693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1E3BF45-42F6-E6C2-4821-9742F825032E}"/>
              </a:ext>
            </a:extLst>
          </p:cNvPr>
          <p:cNvSpPr txBox="1"/>
          <p:nvPr/>
        </p:nvSpPr>
        <p:spPr>
          <a:xfrm rot="16200000">
            <a:off x="3383722" y="3139853"/>
            <a:ext cx="8207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/DEA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80D25AC-26E3-99F9-46EB-B318A292611C}"/>
              </a:ext>
            </a:extLst>
          </p:cNvPr>
          <p:cNvSpPr txBox="1"/>
          <p:nvPr/>
        </p:nvSpPr>
        <p:spPr>
          <a:xfrm>
            <a:off x="2494915" y="3945774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15A4196-B32B-F2E9-5C47-A7EF4DCEBC98}"/>
              </a:ext>
            </a:extLst>
          </p:cNvPr>
          <p:cNvSpPr txBox="1"/>
          <p:nvPr/>
        </p:nvSpPr>
        <p:spPr>
          <a:xfrm>
            <a:off x="4343399" y="3945774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90E5FA1-F0AE-B0E5-0BDD-087A419CDC30}"/>
              </a:ext>
            </a:extLst>
          </p:cNvPr>
          <p:cNvSpPr txBox="1"/>
          <p:nvPr/>
        </p:nvSpPr>
        <p:spPr>
          <a:xfrm rot="16200000">
            <a:off x="5141597" y="2903192"/>
            <a:ext cx="8207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lang="en-I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0DC5156-ACE6-FC98-BB18-228289BB8F18}"/>
              </a:ext>
            </a:extLst>
          </p:cNvPr>
          <p:cNvSpPr txBox="1"/>
          <p:nvPr/>
        </p:nvSpPr>
        <p:spPr>
          <a:xfrm>
            <a:off x="6191883" y="3924333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8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51AFDE9-66EB-BA2E-8D41-7B4508673807}"/>
              </a:ext>
            </a:extLst>
          </p:cNvPr>
          <p:cNvCxnSpPr>
            <a:cxnSpLocks/>
          </p:cNvCxnSpPr>
          <p:nvPr/>
        </p:nvCxnSpPr>
        <p:spPr>
          <a:xfrm>
            <a:off x="3305637" y="3229926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E31608A3-3A2B-5779-FC58-049D88015439}"/>
              </a:ext>
            </a:extLst>
          </p:cNvPr>
          <p:cNvCxnSpPr>
            <a:cxnSpLocks/>
          </p:cNvCxnSpPr>
          <p:nvPr/>
        </p:nvCxnSpPr>
        <p:spPr>
          <a:xfrm>
            <a:off x="5117323" y="3203305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85CAA2A4-4D49-9996-AA78-22E780BA62D2}"/>
              </a:ext>
            </a:extLst>
          </p:cNvPr>
          <p:cNvCxnSpPr>
            <a:cxnSpLocks/>
          </p:cNvCxnSpPr>
          <p:nvPr/>
        </p:nvCxnSpPr>
        <p:spPr>
          <a:xfrm flipV="1">
            <a:off x="6970111" y="2492799"/>
            <a:ext cx="526999" cy="5580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278D19E8-553A-79AE-5433-157DB05AE2CB}"/>
              </a:ext>
            </a:extLst>
          </p:cNvPr>
          <p:cNvCxnSpPr>
            <a:cxnSpLocks/>
          </p:cNvCxnSpPr>
          <p:nvPr/>
        </p:nvCxnSpPr>
        <p:spPr>
          <a:xfrm>
            <a:off x="6970111" y="3640284"/>
            <a:ext cx="853819" cy="33654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E3DD9A61-31E6-9307-3BD0-3EBB36F34A60}"/>
              </a:ext>
            </a:extLst>
          </p:cNvPr>
          <p:cNvSpPr txBox="1"/>
          <p:nvPr/>
        </p:nvSpPr>
        <p:spPr>
          <a:xfrm rot="16200000">
            <a:off x="6739904" y="1315539"/>
            <a:ext cx="6951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ϒ</a:t>
            </a:r>
            <a:endParaRPr lang="en-I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37350DF-E5D2-611A-2B08-BE08A4B7335C}"/>
              </a:ext>
            </a:extLst>
          </p:cNvPr>
          <p:cNvSpPr txBox="1"/>
          <p:nvPr/>
        </p:nvSpPr>
        <p:spPr>
          <a:xfrm>
            <a:off x="7634340" y="2032089"/>
            <a:ext cx="5724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Arial" panose="020B0604020202020204" pitchFamily="34" charset="0"/>
                <a:cs typeface="Arial" panose="020B0604020202020204" pitchFamily="34" charset="0"/>
              </a:rPr>
              <a:t>Gr-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2EE428E-1867-EC28-64C3-0B2A08FCF355}"/>
              </a:ext>
            </a:extLst>
          </p:cNvPr>
          <p:cNvSpPr txBox="1"/>
          <p:nvPr/>
        </p:nvSpPr>
        <p:spPr>
          <a:xfrm rot="16200000">
            <a:off x="6752727" y="4645573"/>
            <a:ext cx="665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I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362011F-049C-38FD-089F-5BE43FD2FB1A}"/>
              </a:ext>
            </a:extLst>
          </p:cNvPr>
          <p:cNvSpPr txBox="1"/>
          <p:nvPr/>
        </p:nvSpPr>
        <p:spPr>
          <a:xfrm>
            <a:off x="7595655" y="5422910"/>
            <a:ext cx="7227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IN" sz="900" b="1" dirty="0">
                <a:latin typeface="Arial" panose="020B0604020202020204" pitchFamily="34" charset="0"/>
                <a:cs typeface="Arial" panose="020B0604020202020204" pitchFamily="34" charset="0"/>
              </a:rPr>
              <a:t>erf-C</a:t>
            </a:r>
          </a:p>
        </p:txBody>
      </p:sp>
    </p:spTree>
    <p:extLst>
      <p:ext uri="{BB962C8B-B14F-4D97-AF65-F5344CB8AC3E}">
        <p14:creationId xmlns:p14="http://schemas.microsoft.com/office/powerpoint/2010/main" val="24195612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5"/>
          <p:cNvPicPr>
            <a:picLocks noGrp="1" noChangeAspect="1"/>
          </p:cNvPicPr>
          <p:nvPr>
            <p:ph sz="half" idx="1"/>
          </p:nvPr>
        </p:nvPicPr>
        <p:blipFill rotWithShape="1">
          <a:blip r:embed="rId2"/>
          <a:srcRect l="7244" b="7165"/>
          <a:stretch>
            <a:fillRect/>
          </a:stretch>
        </p:blipFill>
        <p:spPr>
          <a:xfrm>
            <a:off x="6917778" y="1324017"/>
            <a:ext cx="1243426" cy="1225296"/>
          </a:xfrm>
          <a:prstGeom prst="rect">
            <a:avLst/>
          </a:prstGeom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FB5E3873-C827-4EB5-86FB-CC6CBABB1920}"/>
              </a:ext>
            </a:extLst>
          </p:cNvPr>
          <p:cNvCxnSpPr>
            <a:cxnSpLocks/>
          </p:cNvCxnSpPr>
          <p:nvPr/>
        </p:nvCxnSpPr>
        <p:spPr>
          <a:xfrm>
            <a:off x="3723989" y="2065498"/>
            <a:ext cx="3528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Group 23"/>
          <p:cNvGrpSpPr/>
          <p:nvPr/>
        </p:nvGrpSpPr>
        <p:grpSpPr>
          <a:xfrm>
            <a:off x="282493" y="1010974"/>
            <a:ext cx="9064655" cy="1859221"/>
            <a:chOff x="211933" y="1096525"/>
            <a:chExt cx="9064655" cy="1859221"/>
          </a:xfrm>
        </p:grpSpPr>
        <p:grpSp>
          <p:nvGrpSpPr>
            <p:cNvPr id="21" name="Group 20"/>
            <p:cNvGrpSpPr/>
            <p:nvPr/>
          </p:nvGrpSpPr>
          <p:grpSpPr>
            <a:xfrm>
              <a:off x="211933" y="1499618"/>
              <a:ext cx="1396694" cy="1456128"/>
              <a:chOff x="211933" y="1499618"/>
              <a:chExt cx="1396694" cy="1456128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3"/>
              <a:srcRect l="6337" t="-3380" b="3380"/>
              <a:stretch/>
            </p:blipFill>
            <p:spPr>
              <a:xfrm>
                <a:off x="442764" y="1499618"/>
                <a:ext cx="1165863" cy="1225296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E8AA617-F964-4C32-AE53-BC514CF8A35F}"/>
                  </a:ext>
                </a:extLst>
              </p:cNvPr>
              <p:cNvSpPr txBox="1"/>
              <p:nvPr/>
            </p:nvSpPr>
            <p:spPr>
              <a:xfrm rot="16200000">
                <a:off x="16822" y="1996849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096F725-548F-4E1B-85A8-DB570960EAA6}"/>
                  </a:ext>
                </a:extLst>
              </p:cNvPr>
              <p:cNvSpPr txBox="1"/>
              <p:nvPr/>
            </p:nvSpPr>
            <p:spPr>
              <a:xfrm>
                <a:off x="815272" y="2724914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</p:grp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02987A70-23FA-4AD1-9D85-9EEC4595072D}"/>
                </a:ext>
              </a:extLst>
            </p:cNvPr>
            <p:cNvCxnSpPr>
              <a:cxnSpLocks/>
            </p:cNvCxnSpPr>
            <p:nvPr/>
          </p:nvCxnSpPr>
          <p:spPr>
            <a:xfrm>
              <a:off x="1608627" y="2065498"/>
              <a:ext cx="3528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" name="Group 22"/>
            <p:cNvGrpSpPr/>
            <p:nvPr/>
          </p:nvGrpSpPr>
          <p:grpSpPr>
            <a:xfrm>
              <a:off x="2260292" y="1471557"/>
              <a:ext cx="3499999" cy="1484189"/>
              <a:chOff x="2260292" y="1471557"/>
              <a:chExt cx="3499999" cy="1484189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4"/>
              <a:srcRect l="8181" b="4995"/>
              <a:stretch/>
            </p:blipFill>
            <p:spPr>
              <a:xfrm>
                <a:off x="4557283" y="1471557"/>
                <a:ext cx="1203008" cy="1225296"/>
              </a:xfrm>
              <a:prstGeom prst="rect">
                <a:avLst/>
              </a:prstGeom>
            </p:spPr>
          </p:pic>
          <p:grpSp>
            <p:nvGrpSpPr>
              <p:cNvPr id="22" name="Group 21"/>
              <p:cNvGrpSpPr/>
              <p:nvPr/>
            </p:nvGrpSpPr>
            <p:grpSpPr>
              <a:xfrm>
                <a:off x="2260292" y="1499618"/>
                <a:ext cx="1463697" cy="1456128"/>
                <a:chOff x="2260292" y="1499618"/>
                <a:chExt cx="1463697" cy="1456128"/>
              </a:xfrm>
            </p:grpSpPr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8291" b="5223"/>
                <a:stretch/>
              </p:blipFill>
              <p:spPr>
                <a:xfrm>
                  <a:off x="2493177" y="1499618"/>
                  <a:ext cx="1230812" cy="1225296"/>
                </a:xfrm>
                <a:prstGeom prst="rect">
                  <a:avLst/>
                </a:prstGeom>
              </p:spPr>
            </p:pic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A775B00C-2316-4DD7-8AD7-9A89877C572D}"/>
                    </a:ext>
                  </a:extLst>
                </p:cNvPr>
                <p:cNvSpPr txBox="1"/>
                <p:nvPr/>
              </p:nvSpPr>
              <p:spPr>
                <a:xfrm rot="16200000">
                  <a:off x="2091479" y="1996848"/>
                  <a:ext cx="56845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H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BA6761CE-F912-4C99-9297-05F70BD66F9D}"/>
                    </a:ext>
                  </a:extLst>
                </p:cNvPr>
                <p:cNvSpPr txBox="1"/>
                <p:nvPr/>
              </p:nvSpPr>
              <p:spPr>
                <a:xfrm>
                  <a:off x="2890696" y="2724914"/>
                  <a:ext cx="62105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</a:p>
              </p:txBody>
            </p:sp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E655C9F-3897-4085-9AC3-F656ED833BE4}"/>
                  </a:ext>
                </a:extLst>
              </p:cNvPr>
              <p:cNvSpPr txBox="1"/>
              <p:nvPr/>
            </p:nvSpPr>
            <p:spPr>
              <a:xfrm rot="16200000">
                <a:off x="3930393" y="1968789"/>
                <a:ext cx="11013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TOX BLUE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A6761CE-F912-4C99-9297-05F70BD66F9D}"/>
                  </a:ext>
                </a:extLst>
              </p:cNvPr>
              <p:cNvSpPr txBox="1"/>
              <p:nvPr/>
            </p:nvSpPr>
            <p:spPr>
              <a:xfrm>
                <a:off x="4966120" y="2643272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</p:grp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FB5E3873-C827-4EB5-86FB-CC6CBABB1920}"/>
                </a:ext>
              </a:extLst>
            </p:cNvPr>
            <p:cNvCxnSpPr>
              <a:cxnSpLocks/>
            </p:cNvCxnSpPr>
            <p:nvPr/>
          </p:nvCxnSpPr>
          <p:spPr>
            <a:xfrm>
              <a:off x="5760291" y="2022216"/>
              <a:ext cx="3528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 rot="16200000">
              <a:off x="6026590" y="1686321"/>
              <a:ext cx="14104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ROX APC</a:t>
              </a:r>
              <a:endPara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A6761CE-F912-4C99-9297-05F70BD66F9D}"/>
                </a:ext>
              </a:extLst>
            </p:cNvPr>
            <p:cNvSpPr txBox="1"/>
            <p:nvPr/>
          </p:nvSpPr>
          <p:spPr>
            <a:xfrm>
              <a:off x="7214662" y="2581437"/>
              <a:ext cx="20619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</p:grp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6"/>
          <a:srcRect l="6558" b="6414"/>
          <a:stretch/>
        </p:blipFill>
        <p:spPr>
          <a:xfrm>
            <a:off x="612788" y="4487649"/>
            <a:ext cx="1242835" cy="122529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EE8AA617-F964-4C32-AE53-BC514CF8A35F}"/>
              </a:ext>
            </a:extLst>
          </p:cNvPr>
          <p:cNvSpPr txBox="1"/>
          <p:nvPr/>
        </p:nvSpPr>
        <p:spPr>
          <a:xfrm rot="16200000">
            <a:off x="252231" y="5040053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2987A70-23FA-4AD1-9D85-9EEC4595072D}"/>
              </a:ext>
            </a:extLst>
          </p:cNvPr>
          <p:cNvCxnSpPr>
            <a:cxnSpLocks/>
          </p:cNvCxnSpPr>
          <p:nvPr/>
        </p:nvCxnSpPr>
        <p:spPr>
          <a:xfrm>
            <a:off x="1855623" y="5021267"/>
            <a:ext cx="7060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7"/>
          <a:srcRect l="7787" b="6109"/>
          <a:stretch/>
        </p:blipFill>
        <p:spPr>
          <a:xfrm>
            <a:off x="3048753" y="4408620"/>
            <a:ext cx="1249253" cy="1225296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775B00C-2316-4DD7-8AD7-9A89877C572D}"/>
              </a:ext>
            </a:extLst>
          </p:cNvPr>
          <p:cNvSpPr txBox="1"/>
          <p:nvPr/>
        </p:nvSpPr>
        <p:spPr>
          <a:xfrm rot="16200000">
            <a:off x="2640816" y="4905851"/>
            <a:ext cx="5684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A6761CE-F912-4C99-9297-05F70BD66F9D}"/>
              </a:ext>
            </a:extLst>
          </p:cNvPr>
          <p:cNvSpPr txBox="1"/>
          <p:nvPr/>
        </p:nvSpPr>
        <p:spPr>
          <a:xfrm>
            <a:off x="3481173" y="5597529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02987A70-23FA-4AD1-9D85-9EEC4595072D}"/>
              </a:ext>
            </a:extLst>
          </p:cNvPr>
          <p:cNvCxnSpPr>
            <a:cxnSpLocks/>
          </p:cNvCxnSpPr>
          <p:nvPr/>
        </p:nvCxnSpPr>
        <p:spPr>
          <a:xfrm flipV="1">
            <a:off x="4306298" y="4942938"/>
            <a:ext cx="923049" cy="17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8"/>
          <a:srcRect l="5610" b="7361"/>
          <a:stretch/>
        </p:blipFill>
        <p:spPr>
          <a:xfrm>
            <a:off x="5715435" y="4300582"/>
            <a:ext cx="1268271" cy="1225296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63F02B15-31F8-4583-B500-F8A43ECFA164}"/>
              </a:ext>
            </a:extLst>
          </p:cNvPr>
          <p:cNvSpPr txBox="1"/>
          <p:nvPr/>
        </p:nvSpPr>
        <p:spPr>
          <a:xfrm rot="16200000">
            <a:off x="5435206" y="4768913"/>
            <a:ext cx="5604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85D2A2F-0DB5-35A8-A1D1-81A6A019F0E5}"/>
              </a:ext>
            </a:extLst>
          </p:cNvPr>
          <p:cNvSpPr txBox="1"/>
          <p:nvPr/>
        </p:nvSpPr>
        <p:spPr>
          <a:xfrm>
            <a:off x="5830851" y="5525878"/>
            <a:ext cx="21246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XRos Red PE CF594</a:t>
            </a:r>
            <a:endParaRPr lang="en-I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A6761CE-F912-4C99-9297-05F70BD66F9D}"/>
              </a:ext>
            </a:extLst>
          </p:cNvPr>
          <p:cNvSpPr txBox="1"/>
          <p:nvPr/>
        </p:nvSpPr>
        <p:spPr>
          <a:xfrm>
            <a:off x="1011872" y="5712945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31480" y="6012065"/>
            <a:ext cx="857547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. Fig 6a. Gating strategy to determine cellular ROS in CD8+ T cells of  both SLE patients and healthy controls.</a:t>
            </a:r>
          </a:p>
          <a:p>
            <a:pPr lvl="0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g 6b. Gating strategy to determine mitochondrial hyperpolarization in CD8+ T cells of SLE patients and healthy controls.</a:t>
            </a:r>
            <a:endParaRPr lang="en-IN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31480" y="23554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6a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49625" y="3540113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6b</a:t>
            </a:r>
          </a:p>
        </p:txBody>
      </p:sp>
    </p:spTree>
    <p:extLst>
      <p:ext uri="{BB962C8B-B14F-4D97-AF65-F5344CB8AC3E}">
        <p14:creationId xmlns:p14="http://schemas.microsoft.com/office/powerpoint/2010/main" val="19805340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itle 1">
            <a:extLst>
              <a:ext uri="{FF2B5EF4-FFF2-40B4-BE49-F238E27FC236}">
                <a16:creationId xmlns:a16="http://schemas.microsoft.com/office/drawing/2014/main" id="{44B638D2-6DC7-48C0-8F8D-A39CE1563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1479" y="5672060"/>
            <a:ext cx="7959619" cy="496538"/>
          </a:xfrm>
        </p:spPr>
        <p:txBody>
          <a:bodyPr>
            <a:normAutofit fontScale="90000"/>
          </a:bodyPr>
          <a:lstStyle/>
          <a:p>
            <a:r>
              <a:rPr lang="en-US" sz="1300" b="1" dirty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. Fig 7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to determine phospho -STAT proteins from CD8+ T cells of SLE patients and healthy controls.</a:t>
            </a:r>
            <a:b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IN" sz="1200" dirty="0"/>
          </a:p>
        </p:txBody>
      </p:sp>
      <p:grpSp>
        <p:nvGrpSpPr>
          <p:cNvPr id="3" name="Group 2"/>
          <p:cNvGrpSpPr/>
          <p:nvPr/>
        </p:nvGrpSpPr>
        <p:grpSpPr>
          <a:xfrm>
            <a:off x="0" y="1080275"/>
            <a:ext cx="8393742" cy="4085605"/>
            <a:chOff x="0" y="1058779"/>
            <a:chExt cx="8393742" cy="408560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6AEDA13-08F0-4DB9-975C-F24F14A873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148" r="-6148" b="3277"/>
            <a:stretch/>
          </p:blipFill>
          <p:spPr>
            <a:xfrm>
              <a:off x="3512533" y="2767834"/>
              <a:ext cx="1286927" cy="1225296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3F02B15-31F8-4583-B500-F8A43ECFA164}"/>
                </a:ext>
              </a:extLst>
            </p:cNvPr>
            <p:cNvSpPr txBox="1"/>
            <p:nvPr/>
          </p:nvSpPr>
          <p:spPr>
            <a:xfrm rot="16200000">
              <a:off x="3058683" y="3313583"/>
              <a:ext cx="820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/DEAD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F8FB4B3-D496-47A2-915D-72A4B3E1C744}"/>
                </a:ext>
              </a:extLst>
            </p:cNvPr>
            <p:cNvSpPr txBox="1"/>
            <p:nvPr/>
          </p:nvSpPr>
          <p:spPr>
            <a:xfrm>
              <a:off x="3913434" y="4075021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0" y="2836414"/>
              <a:ext cx="3230046" cy="1489966"/>
              <a:chOff x="-35017" y="2844109"/>
              <a:chExt cx="3230046" cy="1489966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07B3E8BD-9155-4F6A-AFE6-94823F1FEB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438" b="3903"/>
              <a:stretch/>
            </p:blipFill>
            <p:spPr>
              <a:xfrm>
                <a:off x="1674117" y="2844109"/>
                <a:ext cx="1238426" cy="1225296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F3D39BFC-152F-4EB6-9F17-EAE2D3BD30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-35017" y="3067131"/>
                <a:ext cx="246910" cy="626418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16E50D3-63F5-42AD-B6B4-8282055729B7}"/>
                  </a:ext>
                </a:extLst>
              </p:cNvPr>
              <p:cNvSpPr txBox="1"/>
              <p:nvPr/>
            </p:nvSpPr>
            <p:spPr>
              <a:xfrm>
                <a:off x="510765" y="4103243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AA19A4A-10A7-43FF-A61B-2BF6C2BB5D1D}"/>
                  </a:ext>
                </a:extLst>
              </p:cNvPr>
              <p:cNvSpPr txBox="1"/>
              <p:nvPr/>
            </p:nvSpPr>
            <p:spPr>
              <a:xfrm rot="16200000">
                <a:off x="1389889" y="3235944"/>
                <a:ext cx="568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H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42E481C-2FD1-4DBA-B53A-E7A2B7783DA8}"/>
                  </a:ext>
                </a:extLst>
              </p:cNvPr>
              <p:cNvSpPr txBox="1"/>
              <p:nvPr/>
            </p:nvSpPr>
            <p:spPr>
              <a:xfrm>
                <a:off x="2130184" y="4075042"/>
                <a:ext cx="6210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1E2E0E03-6802-4F25-BB80-C25F2B5AD0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90506" y="3441030"/>
                <a:ext cx="20774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3FB0691C-EB03-4A9E-B168-B2AF6E7869A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27857" y="3388177"/>
                <a:ext cx="267172" cy="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2D3A576F-DC21-43CD-BD21-353CBD9C1B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38019" y="2283380"/>
              <a:ext cx="1331775" cy="95070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2D3A576F-DC21-43CD-BD21-353CBD9C1B37}"/>
                </a:ext>
              </a:extLst>
            </p:cNvPr>
            <p:cNvCxnSpPr>
              <a:cxnSpLocks/>
            </p:cNvCxnSpPr>
            <p:nvPr/>
          </p:nvCxnSpPr>
          <p:spPr>
            <a:xfrm>
              <a:off x="4838019" y="3692789"/>
              <a:ext cx="1562781" cy="4856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5"/>
            <a:srcRect l="8175" b="5873"/>
            <a:stretch/>
          </p:blipFill>
          <p:spPr>
            <a:xfrm>
              <a:off x="6833936" y="3359072"/>
              <a:ext cx="1559806" cy="155448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F8FB4B3-D496-47A2-915D-72A4B3E1C744}"/>
                </a:ext>
              </a:extLst>
            </p:cNvPr>
            <p:cNvSpPr txBox="1"/>
            <p:nvPr/>
          </p:nvSpPr>
          <p:spPr>
            <a:xfrm>
              <a:off x="7434154" y="4913552"/>
              <a:ext cx="7569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STAT4</a:t>
              </a: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6"/>
            <a:srcRect l="8792" t="-6095" r="-312" b="6095"/>
            <a:stretch/>
          </p:blipFill>
          <p:spPr>
            <a:xfrm>
              <a:off x="6833936" y="1058779"/>
              <a:ext cx="1464689" cy="1555956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F8FB4B3-D496-47A2-915D-72A4B3E1C744}"/>
                </a:ext>
              </a:extLst>
            </p:cNvPr>
            <p:cNvSpPr txBox="1"/>
            <p:nvPr/>
          </p:nvSpPr>
          <p:spPr>
            <a:xfrm>
              <a:off x="7355548" y="2567326"/>
              <a:ext cx="7569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STAT3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3F02B15-31F8-4583-B500-F8A43ECFA164}"/>
                </a:ext>
              </a:extLst>
            </p:cNvPr>
            <p:cNvSpPr txBox="1"/>
            <p:nvPr/>
          </p:nvSpPr>
          <p:spPr>
            <a:xfrm rot="16200000">
              <a:off x="6438291" y="1791482"/>
              <a:ext cx="5604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3F02B15-31F8-4583-B500-F8A43ECFA164}"/>
                </a:ext>
              </a:extLst>
            </p:cNvPr>
            <p:cNvSpPr txBox="1"/>
            <p:nvPr/>
          </p:nvSpPr>
          <p:spPr>
            <a:xfrm rot="16200000">
              <a:off x="6456456" y="4075021"/>
              <a:ext cx="5604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31480" y="23554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7</a:t>
            </a: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7"/>
          <a:srcRect l="11336" t="-4435" r="-1729" b="4435"/>
          <a:stretch/>
        </p:blipFill>
        <p:spPr>
          <a:xfrm>
            <a:off x="174226" y="2837846"/>
            <a:ext cx="1135882" cy="1225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0659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7194" b="5721"/>
          <a:stretch/>
        </p:blipFill>
        <p:spPr>
          <a:xfrm>
            <a:off x="281204" y="1709464"/>
            <a:ext cx="1655545" cy="165554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6249" b="5311"/>
          <a:stretch/>
        </p:blipFill>
        <p:spPr>
          <a:xfrm>
            <a:off x="2510189" y="1709464"/>
            <a:ext cx="1684365" cy="163878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8567" t="-5399" r="-1635" b="5399"/>
          <a:stretch/>
        </p:blipFill>
        <p:spPr>
          <a:xfrm>
            <a:off x="4896051" y="1588037"/>
            <a:ext cx="1664208" cy="176021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l="6700" b="5549"/>
          <a:stretch/>
        </p:blipFill>
        <p:spPr>
          <a:xfrm>
            <a:off x="7153856" y="1693184"/>
            <a:ext cx="1660851" cy="165506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31480" y="23554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8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44B638D2-6DC7-48C0-8F8D-A39CE1563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1479" y="5672060"/>
            <a:ext cx="7959619" cy="496538"/>
          </a:xfrm>
        </p:spPr>
        <p:txBody>
          <a:bodyPr>
            <a:normAutofit/>
          </a:bodyPr>
          <a:lstStyle/>
          <a:p>
            <a:r>
              <a:rPr lang="en-US" sz="1300" b="1" dirty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. Fig 8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to determine phospho mTOR proteins from CD8+ T cells of SLE patients .</a:t>
            </a:r>
            <a:b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IN" sz="1200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E2E0E03-6802-4F25-BB80-C25F2B5AD0ED}"/>
              </a:ext>
            </a:extLst>
          </p:cNvPr>
          <p:cNvCxnSpPr>
            <a:cxnSpLocks/>
          </p:cNvCxnSpPr>
          <p:nvPr/>
        </p:nvCxnSpPr>
        <p:spPr>
          <a:xfrm>
            <a:off x="1936749" y="2490060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1E2E0E03-6802-4F25-BB80-C25F2B5AD0ED}"/>
              </a:ext>
            </a:extLst>
          </p:cNvPr>
          <p:cNvCxnSpPr>
            <a:cxnSpLocks/>
          </p:cNvCxnSpPr>
          <p:nvPr/>
        </p:nvCxnSpPr>
        <p:spPr>
          <a:xfrm>
            <a:off x="4194554" y="2490060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E2E0E03-6802-4F25-BB80-C25F2B5AD0ED}"/>
              </a:ext>
            </a:extLst>
          </p:cNvPr>
          <p:cNvCxnSpPr>
            <a:cxnSpLocks/>
          </p:cNvCxnSpPr>
          <p:nvPr/>
        </p:nvCxnSpPr>
        <p:spPr>
          <a:xfrm>
            <a:off x="6560259" y="2490060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EE8AA617-F964-4C32-AE53-BC514CF8A35F}"/>
              </a:ext>
            </a:extLst>
          </p:cNvPr>
          <p:cNvSpPr txBox="1"/>
          <p:nvPr/>
        </p:nvSpPr>
        <p:spPr>
          <a:xfrm rot="16200000">
            <a:off x="-84260" y="2326428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096F725-548F-4E1B-85A8-DB570960EAA6}"/>
              </a:ext>
            </a:extLst>
          </p:cNvPr>
          <p:cNvSpPr txBox="1"/>
          <p:nvPr/>
        </p:nvSpPr>
        <p:spPr>
          <a:xfrm>
            <a:off x="969389" y="3365010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096F725-548F-4E1B-85A8-DB570960EAA6}"/>
              </a:ext>
            </a:extLst>
          </p:cNvPr>
          <p:cNvSpPr txBox="1"/>
          <p:nvPr/>
        </p:nvSpPr>
        <p:spPr>
          <a:xfrm>
            <a:off x="3195895" y="3365010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775B00C-2316-4DD7-8AD7-9A89877C572D}"/>
              </a:ext>
            </a:extLst>
          </p:cNvPr>
          <p:cNvSpPr txBox="1"/>
          <p:nvPr/>
        </p:nvSpPr>
        <p:spPr>
          <a:xfrm rot="16200000">
            <a:off x="2190281" y="2352725"/>
            <a:ext cx="5684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3F02B15-31F8-4583-B500-F8A43ECFA164}"/>
              </a:ext>
            </a:extLst>
          </p:cNvPr>
          <p:cNvSpPr txBox="1"/>
          <p:nvPr/>
        </p:nvSpPr>
        <p:spPr>
          <a:xfrm rot="16200000">
            <a:off x="4393326" y="2374644"/>
            <a:ext cx="8207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/DEA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F8FB4B3-D496-47A2-915D-72A4B3E1C744}"/>
              </a:ext>
            </a:extLst>
          </p:cNvPr>
          <p:cNvSpPr txBox="1"/>
          <p:nvPr/>
        </p:nvSpPr>
        <p:spPr>
          <a:xfrm>
            <a:off x="5607480" y="3365010"/>
            <a:ext cx="6210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3F02B15-31F8-4583-B500-F8A43ECFA164}"/>
              </a:ext>
            </a:extLst>
          </p:cNvPr>
          <p:cNvSpPr txBox="1"/>
          <p:nvPr/>
        </p:nvSpPr>
        <p:spPr>
          <a:xfrm rot="16200000">
            <a:off x="6801993" y="2421821"/>
            <a:ext cx="5604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F8FB4B3-D496-47A2-915D-72A4B3E1C744}"/>
              </a:ext>
            </a:extLst>
          </p:cNvPr>
          <p:cNvSpPr txBox="1"/>
          <p:nvPr/>
        </p:nvSpPr>
        <p:spPr>
          <a:xfrm>
            <a:off x="7742162" y="3348248"/>
            <a:ext cx="756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mTOR</a:t>
            </a:r>
          </a:p>
        </p:txBody>
      </p:sp>
    </p:spTree>
    <p:extLst>
      <p:ext uri="{BB962C8B-B14F-4D97-AF65-F5344CB8AC3E}">
        <p14:creationId xmlns:p14="http://schemas.microsoft.com/office/powerpoint/2010/main" val="40453175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287894" y="2177093"/>
            <a:ext cx="5366079" cy="1519371"/>
            <a:chOff x="567026" y="762179"/>
            <a:chExt cx="5366079" cy="151937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408C783-B5B7-8E63-B641-9E80B81F16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442" t="-711" r="-685" b="6164"/>
            <a:stretch/>
          </p:blipFill>
          <p:spPr>
            <a:xfrm>
              <a:off x="797858" y="825422"/>
              <a:ext cx="1240985" cy="122529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E8AA617-F964-4C32-AE53-BC514CF8A35F}"/>
                </a:ext>
              </a:extLst>
            </p:cNvPr>
            <p:cNvSpPr txBox="1"/>
            <p:nvPr/>
          </p:nvSpPr>
          <p:spPr>
            <a:xfrm rot="16200000">
              <a:off x="371915" y="1229149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096F725-548F-4E1B-85A8-DB570960EAA6}"/>
                </a:ext>
              </a:extLst>
            </p:cNvPr>
            <p:cNvSpPr txBox="1"/>
            <p:nvPr/>
          </p:nvSpPr>
          <p:spPr>
            <a:xfrm>
              <a:off x="1267772" y="2050718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1E2E0E03-6802-4F25-BB80-C25F2B5AD0ED}"/>
                </a:ext>
              </a:extLst>
            </p:cNvPr>
            <p:cNvCxnSpPr>
              <a:cxnSpLocks/>
            </p:cNvCxnSpPr>
            <p:nvPr/>
          </p:nvCxnSpPr>
          <p:spPr>
            <a:xfrm>
              <a:off x="2038843" y="1335029"/>
              <a:ext cx="2077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C8D5ED0-4BD4-D472-4105-CD4B4968E1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444" b="5453"/>
            <a:stretch/>
          </p:blipFill>
          <p:spPr>
            <a:xfrm>
              <a:off x="2641108" y="784038"/>
              <a:ext cx="1277440" cy="124358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775B00C-2316-4DD7-8AD7-9A89877C572D}"/>
                </a:ext>
              </a:extLst>
            </p:cNvPr>
            <p:cNvSpPr txBox="1"/>
            <p:nvPr/>
          </p:nvSpPr>
          <p:spPr>
            <a:xfrm rot="16200000">
              <a:off x="2264548" y="1202850"/>
              <a:ext cx="5684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096F725-548F-4E1B-85A8-DB570960EAA6}"/>
                </a:ext>
              </a:extLst>
            </p:cNvPr>
            <p:cNvSpPr txBox="1"/>
            <p:nvPr/>
          </p:nvSpPr>
          <p:spPr>
            <a:xfrm>
              <a:off x="3118892" y="2050718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5DB1350-BC7F-9FBC-96B3-8AB9BB98DD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420" b="5900"/>
            <a:stretch/>
          </p:blipFill>
          <p:spPr>
            <a:xfrm>
              <a:off x="4717040" y="762179"/>
              <a:ext cx="1216065" cy="1243584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3F02B15-31F8-4583-B500-F8A43ECFA164}"/>
                </a:ext>
              </a:extLst>
            </p:cNvPr>
            <p:cNvSpPr txBox="1"/>
            <p:nvPr/>
          </p:nvSpPr>
          <p:spPr>
            <a:xfrm rot="16200000">
              <a:off x="4225837" y="1268555"/>
              <a:ext cx="820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/DEAD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F8FB4B3-D496-47A2-915D-72A4B3E1C744}"/>
                </a:ext>
              </a:extLst>
            </p:cNvPr>
            <p:cNvSpPr txBox="1"/>
            <p:nvPr/>
          </p:nvSpPr>
          <p:spPr>
            <a:xfrm>
              <a:off x="5106966" y="2050718"/>
              <a:ext cx="6210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</p:grp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1E2E0E03-6802-4F25-BB80-C25F2B5AD0ED}"/>
              </a:ext>
            </a:extLst>
          </p:cNvPr>
          <p:cNvCxnSpPr>
            <a:cxnSpLocks/>
          </p:cNvCxnSpPr>
          <p:nvPr/>
        </p:nvCxnSpPr>
        <p:spPr>
          <a:xfrm>
            <a:off x="3639416" y="2737435"/>
            <a:ext cx="2077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D3A576F-DC21-43CD-BD21-353CBD9C1B37}"/>
              </a:ext>
            </a:extLst>
          </p:cNvPr>
          <p:cNvCxnSpPr>
            <a:cxnSpLocks/>
          </p:cNvCxnSpPr>
          <p:nvPr/>
        </p:nvCxnSpPr>
        <p:spPr>
          <a:xfrm flipV="1">
            <a:off x="5653973" y="2240336"/>
            <a:ext cx="390692" cy="3671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D3A576F-DC21-43CD-BD21-353CBD9C1B37}"/>
              </a:ext>
            </a:extLst>
          </p:cNvPr>
          <p:cNvCxnSpPr>
            <a:cxnSpLocks/>
          </p:cNvCxnSpPr>
          <p:nvPr/>
        </p:nvCxnSpPr>
        <p:spPr>
          <a:xfrm>
            <a:off x="5650057" y="3017409"/>
            <a:ext cx="585347" cy="1918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AE4B0F1B-247D-7DDF-5ACF-995C22FABE1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174" b="8956"/>
          <a:stretch/>
        </p:blipFill>
        <p:spPr>
          <a:xfrm>
            <a:off x="6201110" y="968170"/>
            <a:ext cx="1268646" cy="124358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F92852E7-AFFE-BC7A-4F28-1B8E5BE7E63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330" b="5845"/>
          <a:stretch/>
        </p:blipFill>
        <p:spPr>
          <a:xfrm>
            <a:off x="6311153" y="2843840"/>
            <a:ext cx="1256808" cy="124358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BD5FD5D-E552-C22A-4D56-71E79681B61F}"/>
              </a:ext>
            </a:extLst>
          </p:cNvPr>
          <p:cNvSpPr txBox="1"/>
          <p:nvPr/>
        </p:nvSpPr>
        <p:spPr>
          <a:xfrm>
            <a:off x="714695" y="5057237"/>
            <a:ext cx="6853265" cy="7540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. Fig 9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. </a:t>
            </a:r>
            <a: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Gating strategy to determine </a:t>
            </a:r>
            <a:r>
              <a:rPr lang="en-IN" sz="1200" b="1" dirty="0">
                <a:solidFill>
                  <a:prstClr val="black"/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Cytotoxic and inflammatory molecules from Tc1 and Tc21 Cells</a:t>
            </a:r>
            <a: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.</a:t>
            </a:r>
            <a:br>
              <a:rPr kumimoji="0" lang="en-I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</a:br>
            <a:endParaRPr lang="en-IN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09EC1DE-6335-941D-6851-938F4EA9DF22}"/>
              </a:ext>
            </a:extLst>
          </p:cNvPr>
          <p:cNvSpPr txBox="1"/>
          <p:nvPr/>
        </p:nvSpPr>
        <p:spPr>
          <a:xfrm rot="16200000">
            <a:off x="5914153" y="1477027"/>
            <a:ext cx="5631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71828"/>
            <a:r>
              <a:rPr lang="en-IN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ϒ</a:t>
            </a:r>
            <a:endParaRPr lang="en-IN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7B9752B-250D-208A-04A9-719EEAE47BF0}"/>
              </a:ext>
            </a:extLst>
          </p:cNvPr>
          <p:cNvSpPr txBox="1"/>
          <p:nvPr/>
        </p:nvSpPr>
        <p:spPr>
          <a:xfrm>
            <a:off x="6634757" y="2177093"/>
            <a:ext cx="609599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71828"/>
            <a:r>
              <a:rPr lang="en-IN" sz="1102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B</a:t>
            </a:r>
            <a:endParaRPr lang="en-IN" sz="1102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8F5C946-1B42-EA2D-E0A3-B2134B2C8ED3}"/>
              </a:ext>
            </a:extLst>
          </p:cNvPr>
          <p:cNvSpPr txBox="1"/>
          <p:nvPr/>
        </p:nvSpPr>
        <p:spPr>
          <a:xfrm rot="16200000">
            <a:off x="5984318" y="3350215"/>
            <a:ext cx="6155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71828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IN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F-α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6DEC279-2159-F24A-3896-3354000E0F00}"/>
              </a:ext>
            </a:extLst>
          </p:cNvPr>
          <p:cNvSpPr txBox="1"/>
          <p:nvPr/>
        </p:nvSpPr>
        <p:spPr>
          <a:xfrm>
            <a:off x="6712263" y="4030629"/>
            <a:ext cx="6095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71828"/>
            <a:r>
              <a:rPr lang="en-IN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f 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87434BD-344D-59BB-EB5B-580922A378A6}"/>
              </a:ext>
            </a:extLst>
          </p:cNvPr>
          <p:cNvSpPr txBox="1"/>
          <p:nvPr/>
        </p:nvSpPr>
        <p:spPr>
          <a:xfrm>
            <a:off x="231480" y="235542"/>
            <a:ext cx="10484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Fig 9</a:t>
            </a:r>
          </a:p>
        </p:txBody>
      </p:sp>
    </p:spTree>
    <p:extLst>
      <p:ext uri="{BB962C8B-B14F-4D97-AF65-F5344CB8AC3E}">
        <p14:creationId xmlns:p14="http://schemas.microsoft.com/office/powerpoint/2010/main" val="2847694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1</TotalTime>
  <Words>441</Words>
  <Application>Microsoft Office PowerPoint</Application>
  <PresentationFormat>On-screen Show (4:3)</PresentationFormat>
  <Paragraphs>129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. Fig 7. Gating strategy to determine phospho -STAT proteins from CD8+ T cells of SLE patients and healthy controls. </vt:lpstr>
      <vt:lpstr>S. Fig 8 . Gating strategy to determine phospho mTOR proteins from CD8+ T cells of SLE patients .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ole of CD8+ T cells in the pathogenesis of SLE</dc:title>
  <dc:creator>soumya sengupta</dc:creator>
  <cp:lastModifiedBy>soumya sengupta</cp:lastModifiedBy>
  <cp:revision>176</cp:revision>
  <dcterms:created xsi:type="dcterms:W3CDTF">2020-02-17T05:47:09Z</dcterms:created>
  <dcterms:modified xsi:type="dcterms:W3CDTF">2022-09-24T10:26:23Z</dcterms:modified>
</cp:coreProperties>
</file>